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546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12377854176676"/>
          <c:y val="4.2726257628554372E-2"/>
          <c:w val="0.80677263933557597"/>
          <c:h val="0.82213849796892746"/>
        </c:manualLayout>
      </c:layout>
      <c:scatterChart>
        <c:scatterStyle val="smoothMarker"/>
        <c:varyColors val="0"/>
        <c:ser>
          <c:idx val="0"/>
          <c:order val="0"/>
          <c:tx>
            <c:v>no Fast_Nodal1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4!$C$1:$C$6</c:f>
              <c:numCache>
                <c:formatCode>General</c:formatCode>
                <c:ptCount val="6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xVal>
          <c:yVal>
            <c:numRef>
              <c:f>Sheet4!$D$1:$D$6</c:f>
              <c:numCache>
                <c:formatCode>General</c:formatCode>
                <c:ptCount val="6"/>
                <c:pt idx="0">
                  <c:v>2.6315789999999999</c:v>
                </c:pt>
                <c:pt idx="1">
                  <c:v>2.8753989999999998</c:v>
                </c:pt>
                <c:pt idx="2">
                  <c:v>3.3940400000000004</c:v>
                </c:pt>
                <c:pt idx="3">
                  <c:v>4.4633370000000001</c:v>
                </c:pt>
                <c:pt idx="4">
                  <c:v>5.5381780000000003</c:v>
                </c:pt>
                <c:pt idx="5">
                  <c:v>6.718802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534-4766-AE19-FAFBE0C21B63}"/>
            </c:ext>
          </c:extLst>
        </c:ser>
        <c:ser>
          <c:idx val="1"/>
          <c:order val="1"/>
          <c:tx>
            <c:v>no Fast_Nodal2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4!$C$1:$C$6</c:f>
              <c:numCache>
                <c:formatCode>General</c:formatCode>
                <c:ptCount val="6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xVal>
          <c:yVal>
            <c:numRef>
              <c:f>Sheet4!$D$14:$D$20</c:f>
              <c:numCache>
                <c:formatCode>General</c:formatCode>
                <c:ptCount val="7"/>
                <c:pt idx="0">
                  <c:v>0</c:v>
                </c:pt>
                <c:pt idx="1">
                  <c:v>2.1052629999999999</c:v>
                </c:pt>
                <c:pt idx="2">
                  <c:v>3.0115150000000002</c:v>
                </c:pt>
                <c:pt idx="3">
                  <c:v>4.90646</c:v>
                </c:pt>
                <c:pt idx="4">
                  <c:v>5.3060489999999998</c:v>
                </c:pt>
                <c:pt idx="5">
                  <c:v>6.2210799999999997</c:v>
                </c:pt>
                <c:pt idx="6">
                  <c:v>7.01923099999999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534-4766-AE19-FAFBE0C21B63}"/>
            </c:ext>
          </c:extLst>
        </c:ser>
        <c:ser>
          <c:idx val="2"/>
          <c:order val="2"/>
          <c:tx>
            <c:v>Base2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4!$C$1:$C$6</c:f>
              <c:numCache>
                <c:formatCode>General</c:formatCode>
                <c:ptCount val="6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xVal>
          <c:yVal>
            <c:numRef>
              <c:f>Sheet4!$Q$1:$Q$7</c:f>
              <c:numCache>
                <c:formatCode>General</c:formatCode>
                <c:ptCount val="7"/>
                <c:pt idx="0">
                  <c:v>0</c:v>
                </c:pt>
                <c:pt idx="1">
                  <c:v>1.5659960000000002</c:v>
                </c:pt>
                <c:pt idx="2">
                  <c:v>2.7706189999999999</c:v>
                </c:pt>
                <c:pt idx="3">
                  <c:v>4.2597560000000003</c:v>
                </c:pt>
                <c:pt idx="4">
                  <c:v>4.7595840000000003</c:v>
                </c:pt>
                <c:pt idx="5">
                  <c:v>5.669003</c:v>
                </c:pt>
                <c:pt idx="6">
                  <c:v>6.89982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534-4766-AE19-FAFBE0C21B63}"/>
            </c:ext>
          </c:extLst>
        </c:ser>
        <c:ser>
          <c:idx val="3"/>
          <c:order val="3"/>
          <c:tx>
            <c:v>Base1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4!$C$1:$C$6</c:f>
              <c:numCache>
                <c:formatCode>General</c:formatCode>
                <c:ptCount val="6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20</c:v>
                </c:pt>
                <c:pt idx="4">
                  <c:v>25</c:v>
                </c:pt>
                <c:pt idx="5">
                  <c:v>30</c:v>
                </c:pt>
              </c:numCache>
            </c:numRef>
          </c:xVal>
          <c:yVal>
            <c:numRef>
              <c:f>Sheet4!$Q$14:$Q$20</c:f>
              <c:numCache>
                <c:formatCode>General</c:formatCode>
                <c:ptCount val="7"/>
                <c:pt idx="0">
                  <c:v>0</c:v>
                </c:pt>
                <c:pt idx="1">
                  <c:v>1.809955</c:v>
                </c:pt>
                <c:pt idx="2">
                  <c:v>3.1660689999999998</c:v>
                </c:pt>
                <c:pt idx="3">
                  <c:v>3.9701569999999999</c:v>
                </c:pt>
                <c:pt idx="4">
                  <c:v>4.7261480000000002</c:v>
                </c:pt>
                <c:pt idx="5">
                  <c:v>5.51532</c:v>
                </c:pt>
                <c:pt idx="6">
                  <c:v>6.447550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534-4766-AE19-FAFBE0C21B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9825760"/>
        <c:axId val="569818216"/>
      </c:scatterChart>
      <c:valAx>
        <c:axId val="5698257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DAE</a:t>
                </a:r>
              </a:p>
            </c:rich>
          </c:tx>
          <c:layout>
            <c:manualLayout>
              <c:xMode val="edge"/>
              <c:yMode val="edge"/>
              <c:x val="0.51892179121781556"/>
              <c:y val="0.937644148393431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69818216"/>
        <c:crosses val="autoZero"/>
        <c:crossBetween val="midCat"/>
      </c:valAx>
      <c:valAx>
        <c:axId val="5698182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overlapping depletion zones (%)</a:t>
                </a:r>
              </a:p>
            </c:rich>
          </c:tx>
          <c:layout>
            <c:manualLayout>
              <c:xMode val="edge"/>
              <c:yMode val="edge"/>
              <c:x val="3.4591697164614986E-2"/>
              <c:y val="0.20244001795314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6982576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360430298325386"/>
          <c:y val="5.6768287328396214E-2"/>
          <c:w val="0.43286286397298929"/>
          <c:h val="0.188036520992496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>
              <a:lumMod val="95000"/>
              <a:lumOff val="5000"/>
            </a:schemeClr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760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672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832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038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421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979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892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726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66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298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089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93E1A-101C-471F-9778-D50693071E2D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4778F8-565E-4AC6-BF25-79ABEBDB6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110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2668604"/>
              </p:ext>
            </p:extLst>
          </p:nvPr>
        </p:nvGraphicFramePr>
        <p:xfrm>
          <a:off x="2278315" y="1190034"/>
          <a:ext cx="4057650" cy="4099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767EEA7B-8B62-4A0A-B645-641B3501FB92}"/>
              </a:ext>
            </a:extLst>
          </p:cNvPr>
          <p:cNvSpPr/>
          <p:nvPr/>
        </p:nvSpPr>
        <p:spPr>
          <a:xfrm>
            <a:off x="665305" y="5528367"/>
            <a:ext cx="799942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400" b="1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S2 </a:t>
            </a:r>
            <a:r>
              <a:rPr lang="en-US" sz="1400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stimation of overlapping depletion zones, comparing the base model with a simulation replacing the fast nodal roots with branched nodal roots.</a:t>
            </a:r>
            <a:endParaRPr lang="en-US" sz="14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74757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3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2</cp:revision>
  <dcterms:created xsi:type="dcterms:W3CDTF">2021-02-08T09:52:55Z</dcterms:created>
  <dcterms:modified xsi:type="dcterms:W3CDTF">2021-02-08T09:57:48Z</dcterms:modified>
</cp:coreProperties>
</file>